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70" r:id="rId3"/>
    <p:sldId id="269" r:id="rId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A523248-7066-4EFB-A0BF-E9EBD35AD425}" v="104" dt="2024-05-18T02:57:10.5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Perez perez moreno" userId="eb0a445b3601a804" providerId="LiveId" clId="{8A523248-7066-4EFB-A0BF-E9EBD35AD425}"/>
    <pc:docChg chg="undo redo custSel addSld delSld modSld sldOrd">
      <pc:chgData name="PPerez perez moreno" userId="eb0a445b3601a804" providerId="LiveId" clId="{8A523248-7066-4EFB-A0BF-E9EBD35AD425}" dt="2024-05-18T02:57:16.923" v="686" actId="27614"/>
      <pc:docMkLst>
        <pc:docMk/>
      </pc:docMkLst>
      <pc:sldChg chg="del">
        <pc:chgData name="PPerez perez moreno" userId="eb0a445b3601a804" providerId="LiveId" clId="{8A523248-7066-4EFB-A0BF-E9EBD35AD425}" dt="2024-05-07T14:54:37.646" v="3" actId="47"/>
        <pc:sldMkLst>
          <pc:docMk/>
          <pc:sldMk cId="3111363747" sldId="256"/>
        </pc:sldMkLst>
      </pc:sldChg>
      <pc:sldChg chg="addSp modSp mod modAnim">
        <pc:chgData name="PPerez perez moreno" userId="eb0a445b3601a804" providerId="LiveId" clId="{8A523248-7066-4EFB-A0BF-E9EBD35AD425}" dt="2024-05-16T18:35:14.950" v="525" actId="20577"/>
        <pc:sldMkLst>
          <pc:docMk/>
          <pc:sldMk cId="1473172840" sldId="268"/>
        </pc:sldMkLst>
        <pc:spChg chg="add mod">
          <ac:chgData name="PPerez perez moreno" userId="eb0a445b3601a804" providerId="LiveId" clId="{8A523248-7066-4EFB-A0BF-E9EBD35AD425}" dt="2024-05-16T18:20:24.039" v="235" actId="113"/>
          <ac:spMkLst>
            <pc:docMk/>
            <pc:sldMk cId="1473172840" sldId="268"/>
            <ac:spMk id="3" creationId="{2B0CA148-8C91-4116-D4AB-810E920C0522}"/>
          </ac:spMkLst>
        </pc:spChg>
        <pc:spChg chg="add mod">
          <ac:chgData name="PPerez perez moreno" userId="eb0a445b3601a804" providerId="LiveId" clId="{8A523248-7066-4EFB-A0BF-E9EBD35AD425}" dt="2024-05-16T18:18:31.057" v="159" actId="255"/>
          <ac:spMkLst>
            <pc:docMk/>
            <pc:sldMk cId="1473172840" sldId="268"/>
            <ac:spMk id="9" creationId="{EC1BC104-30A6-ADCF-1E2D-DD79845ABB62}"/>
          </ac:spMkLst>
        </pc:spChg>
        <pc:spChg chg="add mod">
          <ac:chgData name="PPerez perez moreno" userId="eb0a445b3601a804" providerId="LiveId" clId="{8A523248-7066-4EFB-A0BF-E9EBD35AD425}" dt="2024-05-16T18:18:33.665" v="161" actId="20577"/>
          <ac:spMkLst>
            <pc:docMk/>
            <pc:sldMk cId="1473172840" sldId="268"/>
            <ac:spMk id="10" creationId="{7BB21585-C982-2958-55E6-5BDA213A58B7}"/>
          </ac:spMkLst>
        </pc:spChg>
        <pc:spChg chg="add mod">
          <ac:chgData name="PPerez perez moreno" userId="eb0a445b3601a804" providerId="LiveId" clId="{8A523248-7066-4EFB-A0BF-E9EBD35AD425}" dt="2024-05-16T18:18:31.057" v="159" actId="255"/>
          <ac:spMkLst>
            <pc:docMk/>
            <pc:sldMk cId="1473172840" sldId="268"/>
            <ac:spMk id="11" creationId="{EA44011C-79CB-1AA9-397E-ECF9B979AC25}"/>
          </ac:spMkLst>
        </pc:spChg>
        <pc:spChg chg="add mod">
          <ac:chgData name="PPerez perez moreno" userId="eb0a445b3601a804" providerId="LiveId" clId="{8A523248-7066-4EFB-A0BF-E9EBD35AD425}" dt="2024-05-16T18:18:31.057" v="159" actId="255"/>
          <ac:spMkLst>
            <pc:docMk/>
            <pc:sldMk cId="1473172840" sldId="268"/>
            <ac:spMk id="12" creationId="{C23FCCF5-83B3-7722-34B5-83A5EDEFCE51}"/>
          </ac:spMkLst>
        </pc:spChg>
        <pc:spChg chg="add mod">
          <ac:chgData name="PPerez perez moreno" userId="eb0a445b3601a804" providerId="LiveId" clId="{8A523248-7066-4EFB-A0BF-E9EBD35AD425}" dt="2024-05-16T18:22:42.581" v="261" actId="1076"/>
          <ac:spMkLst>
            <pc:docMk/>
            <pc:sldMk cId="1473172840" sldId="268"/>
            <ac:spMk id="13" creationId="{88E58634-0530-10B3-9751-14552E59FBD4}"/>
          </ac:spMkLst>
        </pc:spChg>
        <pc:spChg chg="add mod">
          <ac:chgData name="PPerez perez moreno" userId="eb0a445b3601a804" providerId="LiveId" clId="{8A523248-7066-4EFB-A0BF-E9EBD35AD425}" dt="2024-05-16T18:35:14.950" v="525" actId="20577"/>
          <ac:spMkLst>
            <pc:docMk/>
            <pc:sldMk cId="1473172840" sldId="268"/>
            <ac:spMk id="14" creationId="{273FC399-B8F3-56AA-AB77-DA68076A4C31}"/>
          </ac:spMkLst>
        </pc:spChg>
        <pc:graphicFrameChg chg="mod">
          <ac:chgData name="PPerez perez moreno" userId="eb0a445b3601a804" providerId="LiveId" clId="{8A523248-7066-4EFB-A0BF-E9EBD35AD425}" dt="2024-05-16T18:15:48.064" v="124" actId="1076"/>
          <ac:graphicFrameMkLst>
            <pc:docMk/>
            <pc:sldMk cId="1473172840" sldId="268"/>
            <ac:graphicFrameMk id="4" creationId="{1F1F9529-F0E1-EEAA-367F-7E53DBFDE9CF}"/>
          </ac:graphicFrameMkLst>
        </pc:graphicFrameChg>
        <pc:graphicFrameChg chg="mod">
          <ac:chgData name="PPerez perez moreno" userId="eb0a445b3601a804" providerId="LiveId" clId="{8A523248-7066-4EFB-A0BF-E9EBD35AD425}" dt="2024-05-16T18:15:51.073" v="126" actId="14100"/>
          <ac:graphicFrameMkLst>
            <pc:docMk/>
            <pc:sldMk cId="1473172840" sldId="268"/>
            <ac:graphicFrameMk id="5" creationId="{E3122D64-9CC6-817C-939F-C296FB7F406B}"/>
          </ac:graphicFrameMkLst>
        </pc:graphicFrameChg>
        <pc:graphicFrameChg chg="mod">
          <ac:chgData name="PPerez perez moreno" userId="eb0a445b3601a804" providerId="LiveId" clId="{8A523248-7066-4EFB-A0BF-E9EBD35AD425}" dt="2024-05-16T18:15:58.297" v="129" actId="1076"/>
          <ac:graphicFrameMkLst>
            <pc:docMk/>
            <pc:sldMk cId="1473172840" sldId="268"/>
            <ac:graphicFrameMk id="7" creationId="{E22C29BB-21B8-F220-E4F4-431BFCC5191B}"/>
          </ac:graphicFrameMkLst>
        </pc:graphicFrameChg>
        <pc:graphicFrameChg chg="mod">
          <ac:chgData name="PPerez perez moreno" userId="eb0a445b3601a804" providerId="LiveId" clId="{8A523248-7066-4EFB-A0BF-E9EBD35AD425}" dt="2024-05-16T18:16:07.380" v="132" actId="1076"/>
          <ac:graphicFrameMkLst>
            <pc:docMk/>
            <pc:sldMk cId="1473172840" sldId="268"/>
            <ac:graphicFrameMk id="8" creationId="{BD215A1C-74EC-5D14-F7D6-B5A973F29A29}"/>
          </ac:graphicFrameMkLst>
        </pc:graphicFrameChg>
      </pc:sldChg>
      <pc:sldChg chg="addSp delSp modSp new mod addAnim delAnim modAnim">
        <pc:chgData name="PPerez perez moreno" userId="eb0a445b3601a804" providerId="LiveId" clId="{8A523248-7066-4EFB-A0BF-E9EBD35AD425}" dt="2024-05-18T02:57:16.923" v="686" actId="27614"/>
        <pc:sldMkLst>
          <pc:docMk/>
          <pc:sldMk cId="394050542" sldId="269"/>
        </pc:sldMkLst>
        <pc:spChg chg="del">
          <ac:chgData name="PPerez perez moreno" userId="eb0a445b3601a804" providerId="LiveId" clId="{8A523248-7066-4EFB-A0BF-E9EBD35AD425}" dt="2024-05-07T14:54:34.199" v="1" actId="478"/>
          <ac:spMkLst>
            <pc:docMk/>
            <pc:sldMk cId="394050542" sldId="269"/>
            <ac:spMk id="2" creationId="{6370F0F6-68F3-500B-D47E-85B59A661F6A}"/>
          </ac:spMkLst>
        </pc:spChg>
        <pc:spChg chg="add mod">
          <ac:chgData name="PPerez perez moreno" userId="eb0a445b3601a804" providerId="LiveId" clId="{8A523248-7066-4EFB-A0BF-E9EBD35AD425}" dt="2024-05-16T20:12:34.796" v="669" actId="5793"/>
          <ac:spMkLst>
            <pc:docMk/>
            <pc:sldMk cId="394050542" sldId="269"/>
            <ac:spMk id="2" creationId="{BBF6C967-3CCD-3A72-2C59-75CF12FC4A78}"/>
          </ac:spMkLst>
        </pc:spChg>
        <pc:spChg chg="del">
          <ac:chgData name="PPerez perez moreno" userId="eb0a445b3601a804" providerId="LiveId" clId="{8A523248-7066-4EFB-A0BF-E9EBD35AD425}" dt="2024-05-07T14:54:36.822" v="2" actId="478"/>
          <ac:spMkLst>
            <pc:docMk/>
            <pc:sldMk cId="394050542" sldId="269"/>
            <ac:spMk id="3" creationId="{B3C14A89-5D0B-912A-1F76-91C240BFFEE8}"/>
          </ac:spMkLst>
        </pc:spChg>
        <pc:spChg chg="add del mod">
          <ac:chgData name="PPerez perez moreno" userId="eb0a445b3601a804" providerId="LiveId" clId="{8A523248-7066-4EFB-A0BF-E9EBD35AD425}" dt="2024-05-18T02:57:09.735" v="683" actId="478"/>
          <ac:spMkLst>
            <pc:docMk/>
            <pc:sldMk cId="394050542" sldId="269"/>
            <ac:spMk id="5" creationId="{494EE52C-465C-417C-E75C-03BC336BECFC}"/>
          </ac:spMkLst>
        </pc:spChg>
        <pc:spChg chg="add del mod">
          <ac:chgData name="PPerez perez moreno" userId="eb0a445b3601a804" providerId="LiveId" clId="{8A523248-7066-4EFB-A0BF-E9EBD35AD425}" dt="2024-05-18T02:57:09.735" v="683" actId="478"/>
          <ac:spMkLst>
            <pc:docMk/>
            <pc:sldMk cId="394050542" sldId="269"/>
            <ac:spMk id="6" creationId="{2CBE31D2-C382-2A58-448E-F72FFA540649}"/>
          </ac:spMkLst>
        </pc:spChg>
        <pc:spChg chg="add del mod">
          <ac:chgData name="PPerez perez moreno" userId="eb0a445b3601a804" providerId="LiveId" clId="{8A523248-7066-4EFB-A0BF-E9EBD35AD425}" dt="2024-05-18T02:57:09.735" v="683" actId="478"/>
          <ac:spMkLst>
            <pc:docMk/>
            <pc:sldMk cId="394050542" sldId="269"/>
            <ac:spMk id="8" creationId="{CA2A04BF-628C-2ED2-66DB-1135B8B3F4F2}"/>
          </ac:spMkLst>
        </pc:spChg>
        <pc:spChg chg="add del mod">
          <ac:chgData name="PPerez perez moreno" userId="eb0a445b3601a804" providerId="LiveId" clId="{8A523248-7066-4EFB-A0BF-E9EBD35AD425}" dt="2024-05-18T02:56:12.172" v="678" actId="1076"/>
          <ac:spMkLst>
            <pc:docMk/>
            <pc:sldMk cId="394050542" sldId="269"/>
            <ac:spMk id="9" creationId="{7A9DB80D-C5A2-4EEE-C07E-16469C327CD1}"/>
          </ac:spMkLst>
        </pc:spChg>
        <pc:spChg chg="add del mod">
          <ac:chgData name="PPerez perez moreno" userId="eb0a445b3601a804" providerId="LiveId" clId="{8A523248-7066-4EFB-A0BF-E9EBD35AD425}" dt="2024-05-18T02:57:09.735" v="683" actId="478"/>
          <ac:spMkLst>
            <pc:docMk/>
            <pc:sldMk cId="394050542" sldId="269"/>
            <ac:spMk id="10" creationId="{A2AB5FC7-DDD0-21F5-6CCE-8958BFBD313A}"/>
          </ac:spMkLst>
        </pc:spChg>
        <pc:spChg chg="add del mod">
          <ac:chgData name="PPerez perez moreno" userId="eb0a445b3601a804" providerId="LiveId" clId="{8A523248-7066-4EFB-A0BF-E9EBD35AD425}" dt="2024-05-18T02:56:13.182" v="680" actId="478"/>
          <ac:spMkLst>
            <pc:docMk/>
            <pc:sldMk cId="394050542" sldId="269"/>
            <ac:spMk id="11" creationId="{76C8DCBC-A1B6-C606-9682-98F440F7C4D4}"/>
          </ac:spMkLst>
        </pc:spChg>
        <pc:spChg chg="add del mod">
          <ac:chgData name="PPerez perez moreno" userId="eb0a445b3601a804" providerId="LiveId" clId="{8A523248-7066-4EFB-A0BF-E9EBD35AD425}" dt="2024-05-07T15:23:52.144" v="82"/>
          <ac:spMkLst>
            <pc:docMk/>
            <pc:sldMk cId="394050542" sldId="269"/>
            <ac:spMk id="12" creationId="{FB645155-5CBD-2164-064C-1A4D3CA9C331}"/>
          </ac:spMkLst>
        </pc:spChg>
        <pc:graphicFrameChg chg="add del mod">
          <ac:chgData name="PPerez perez moreno" userId="eb0a445b3601a804" providerId="LiveId" clId="{8A523248-7066-4EFB-A0BF-E9EBD35AD425}" dt="2024-05-18T02:56:12.722" v="679" actId="478"/>
          <ac:graphicFrameMkLst>
            <pc:docMk/>
            <pc:sldMk cId="394050542" sldId="269"/>
            <ac:graphicFrameMk id="7" creationId="{E7FE481F-10F5-F42D-4BF6-92A0A0720ABE}"/>
          </ac:graphicFrameMkLst>
        </pc:graphicFrameChg>
        <pc:picChg chg="add del mod">
          <ac:chgData name="PPerez perez moreno" userId="eb0a445b3601a804" providerId="LiveId" clId="{8A523248-7066-4EFB-A0BF-E9EBD35AD425}" dt="2024-05-18T02:57:09.735" v="683" actId="478"/>
          <ac:picMkLst>
            <pc:docMk/>
            <pc:sldMk cId="394050542" sldId="269"/>
            <ac:picMk id="4" creationId="{0797A34F-5101-4A16-EB9B-0B34593B33E1}"/>
          </ac:picMkLst>
        </pc:picChg>
        <pc:picChg chg="add del mod">
          <ac:chgData name="PPerez perez moreno" userId="eb0a445b3601a804" providerId="LiveId" clId="{8A523248-7066-4EFB-A0BF-E9EBD35AD425}" dt="2024-05-18T02:56:15.283" v="682" actId="478"/>
          <ac:picMkLst>
            <pc:docMk/>
            <pc:sldMk cId="394050542" sldId="269"/>
            <ac:picMk id="12" creationId="{46715EB3-C6EE-3615-C6D4-E29CCD0FD49F}"/>
          </ac:picMkLst>
        </pc:picChg>
        <pc:picChg chg="add mod">
          <ac:chgData name="PPerez perez moreno" userId="eb0a445b3601a804" providerId="LiveId" clId="{8A523248-7066-4EFB-A0BF-E9EBD35AD425}" dt="2024-05-18T02:57:16.923" v="686" actId="27614"/>
          <ac:picMkLst>
            <pc:docMk/>
            <pc:sldMk cId="394050542" sldId="269"/>
            <ac:picMk id="14" creationId="{F4BF055C-0308-11B8-4E90-611EF35B31ED}"/>
          </ac:picMkLst>
        </pc:picChg>
      </pc:sldChg>
      <pc:sldChg chg="addSp delSp modSp new mod ord modAnim">
        <pc:chgData name="PPerez perez moreno" userId="eb0a445b3601a804" providerId="LiveId" clId="{8A523248-7066-4EFB-A0BF-E9EBD35AD425}" dt="2024-05-16T18:27:22.706" v="515" actId="20577"/>
        <pc:sldMkLst>
          <pc:docMk/>
          <pc:sldMk cId="405907660" sldId="270"/>
        </pc:sldMkLst>
        <pc:spChg chg="add mod">
          <ac:chgData name="PPerez perez moreno" userId="eb0a445b3601a804" providerId="LiveId" clId="{8A523248-7066-4EFB-A0BF-E9EBD35AD425}" dt="2024-05-16T18:27:22.706" v="515" actId="20577"/>
          <ac:spMkLst>
            <pc:docMk/>
            <pc:sldMk cId="405907660" sldId="270"/>
            <ac:spMk id="2" creationId="{918EE934-4C38-D2B2-2F5D-0CA714CBA468}"/>
          </ac:spMkLst>
        </pc:spChg>
        <pc:spChg chg="del">
          <ac:chgData name="PPerez perez moreno" userId="eb0a445b3601a804" providerId="LiveId" clId="{8A523248-7066-4EFB-A0BF-E9EBD35AD425}" dt="2024-05-14T01:35:00.448" v="89" actId="478"/>
          <ac:spMkLst>
            <pc:docMk/>
            <pc:sldMk cId="405907660" sldId="270"/>
            <ac:spMk id="2" creationId="{9E921888-3226-A87E-458B-AC23D6BE6C30}"/>
          </ac:spMkLst>
        </pc:spChg>
        <pc:spChg chg="del">
          <ac:chgData name="PPerez perez moreno" userId="eb0a445b3601a804" providerId="LiveId" clId="{8A523248-7066-4EFB-A0BF-E9EBD35AD425}" dt="2024-05-14T01:34:59.791" v="88" actId="478"/>
          <ac:spMkLst>
            <pc:docMk/>
            <pc:sldMk cId="405907660" sldId="270"/>
            <ac:spMk id="3" creationId="{6A53761C-8372-B460-E771-21ED79A2F647}"/>
          </ac:spMkLst>
        </pc:spChg>
        <pc:spChg chg="add mod">
          <ac:chgData name="PPerez perez moreno" userId="eb0a445b3601a804" providerId="LiveId" clId="{8A523248-7066-4EFB-A0BF-E9EBD35AD425}" dt="2024-05-16T18:23:14.849" v="270" actId="1076"/>
          <ac:spMkLst>
            <pc:docMk/>
            <pc:sldMk cId="405907660" sldId="270"/>
            <ac:spMk id="3" creationId="{E01A0967-C2ED-78C1-94AE-2AB11A04FF10}"/>
          </ac:spMkLst>
        </pc:spChg>
        <pc:spChg chg="add mod">
          <ac:chgData name="PPerez perez moreno" userId="eb0a445b3601a804" providerId="LiveId" clId="{8A523248-7066-4EFB-A0BF-E9EBD35AD425}" dt="2024-05-16T18:23:14.849" v="270" actId="1076"/>
          <ac:spMkLst>
            <pc:docMk/>
            <pc:sldMk cId="405907660" sldId="270"/>
            <ac:spMk id="5" creationId="{CBEA2E3B-2A52-5BE4-9A5E-5496850B2D9B}"/>
          </ac:spMkLst>
        </pc:spChg>
        <pc:spChg chg="add mod">
          <ac:chgData name="PPerez perez moreno" userId="eb0a445b3601a804" providerId="LiveId" clId="{8A523248-7066-4EFB-A0BF-E9EBD35AD425}" dt="2024-05-16T18:25:09.529" v="445" actId="20577"/>
          <ac:spMkLst>
            <pc:docMk/>
            <pc:sldMk cId="405907660" sldId="270"/>
            <ac:spMk id="6" creationId="{E8DBFB66-1ABB-8F56-94CD-4BA9E7758CC1}"/>
          </ac:spMkLst>
        </pc:spChg>
        <pc:spChg chg="add mod">
          <ac:chgData name="PPerez perez moreno" userId="eb0a445b3601a804" providerId="LiveId" clId="{8A523248-7066-4EFB-A0BF-E9EBD35AD425}" dt="2024-05-16T18:23:14.849" v="270" actId="1076"/>
          <ac:spMkLst>
            <pc:docMk/>
            <pc:sldMk cId="405907660" sldId="270"/>
            <ac:spMk id="8" creationId="{988DCEFF-997F-2F10-BC12-8E168C17B8A3}"/>
          </ac:spMkLst>
        </pc:spChg>
        <pc:graphicFrameChg chg="add mod">
          <ac:chgData name="PPerez perez moreno" userId="eb0a445b3601a804" providerId="LiveId" clId="{8A523248-7066-4EFB-A0BF-E9EBD35AD425}" dt="2024-05-16T18:23:14.849" v="270" actId="1076"/>
          <ac:graphicFrameMkLst>
            <pc:docMk/>
            <pc:sldMk cId="405907660" sldId="270"/>
            <ac:graphicFrameMk id="4" creationId="{7EFBCE06-B8BD-C371-86A4-6B4904838D11}"/>
          </ac:graphicFrameMkLst>
        </pc:graphicFrameChg>
        <pc:graphicFrameChg chg="add del mod">
          <ac:chgData name="PPerez perez moreno" userId="eb0a445b3601a804" providerId="LiveId" clId="{8A523248-7066-4EFB-A0BF-E9EBD35AD425}" dt="2024-05-14T01:44:54.048" v="95" actId="478"/>
          <ac:graphicFrameMkLst>
            <pc:docMk/>
            <pc:sldMk cId="405907660" sldId="270"/>
            <ac:graphicFrameMk id="6" creationId="{C8C9860D-E73D-1CE0-3963-B6BAE5D12972}"/>
          </ac:graphicFrameMkLst>
        </pc:graphicFrameChg>
        <pc:graphicFrameChg chg="add mod">
          <ac:chgData name="PPerez perez moreno" userId="eb0a445b3601a804" providerId="LiveId" clId="{8A523248-7066-4EFB-A0BF-E9EBD35AD425}" dt="2024-05-16T18:23:14.849" v="270" actId="1076"/>
          <ac:graphicFrameMkLst>
            <pc:docMk/>
            <pc:sldMk cId="405907660" sldId="270"/>
            <ac:graphicFrameMk id="7" creationId="{B84AAC8F-D04C-6135-6073-2C00FF1AECF4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F509E4-DD19-70D4-3C80-03C4BABE90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6C8EEDA-ACCE-9128-8857-F6ADF87287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DB1CBF5-37E8-FE8C-DF54-CB1A1D561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92554D6-67C0-9B94-3D55-80D9A115A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6B306EB-E178-EF2B-8BB4-9DC18EACF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32670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3EDD3E-51F7-481B-4B22-4486A1638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DB5367C-338D-E9EE-5660-2EDFB02BB8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D2E2FDE-E264-1357-9F6D-7BF1DEE4B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562A0E-1254-57AE-96EB-FABCE31C3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A59EE1-019F-A16F-5E91-618A5F7EC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27946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259D341-1413-71DA-4697-9E89968B10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69387F4-634E-BE26-92DC-B6E1F2D2E0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5AF3EE4-6C8D-80F2-65AA-0D67E416E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C224BB-2803-76EB-A585-BCCA2D847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450AAE-29E8-19D2-C3D1-4336F5BEF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52136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0FA2DC-6BAE-9D53-1C22-DB6C289EC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27B22D8-047A-5345-D1A5-54987AAF1C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FEB3EC-75F2-6E30-CA04-2A5616DF2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BDB435A-268E-D047-351F-09249853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A010409-937E-175C-690E-938831512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00369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BAD9DB-2B1B-CF0E-10C6-B4F4CC201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FA247B9-9875-8876-EB6F-6D4B329B3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DF0D814-DA4C-9233-285C-2598F319D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11FBF91-4ED7-539D-0423-40FBA25C5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93D0516-D5CB-2564-ED7F-F6357B266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79452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48AC48-0FC0-0D66-17BD-E882E4F73C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7572742-3244-CF3F-F8EC-1F33512481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FC51350-DF33-AE21-566D-EF597420AB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184615E-C7EB-84FF-2BF3-4FFF35F2C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6E1758A-7378-B138-A637-DAA9738FC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09A1A7A-9681-D402-4A17-939750FA1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1575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FC7E10-7FDB-A294-6036-9FD33D5A2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8E8D2D3-ADEC-2E6E-E40E-29C7FE2504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17F9E04-6A05-7B61-A447-F850D4BC1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F911F9F-3400-A5BE-5427-70737BA48E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7662916-2284-0DFE-7935-9AAA91BB4B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7CA754C-508E-7F91-351B-029245A43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355D2D1-1BAC-7DA6-B114-ADEED36F0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2DD0612-AD71-4CB8-D5D0-F2AE40185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17281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FEF840-E4C0-2E93-86AD-759CCFE77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4E991DA-29BE-BDC1-408F-A849BF896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15FE666-70FA-CA8F-DCF0-766DD8CF6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D20EB48-5802-B85A-F1E5-ED4CD360A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9012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2ED15CB-5CE8-F205-007A-C817A05FA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C4FE8E4-93C6-E312-F499-5532A717B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EB3ADAA-2513-AF13-2D61-58D2A49070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81484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331E7F-C63B-57B9-5C33-264614436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227308F-8589-69D8-B885-DF1FAB3015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9F26620-4CDA-D575-C720-2992DFF741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EFC831D-671E-FF1B-C59D-5E6596052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D757579-3D57-525C-B8A8-32C37379F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971A7B9-43F8-E432-3F6F-E0FECB94A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04267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6329B5-7CCA-C3E1-05F7-A19D7ADC0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DF25713-3B3A-AAC4-5F40-1BA0F0B389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4FAC399-AF3C-200D-F317-B4C4015419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E43144E-43D3-DC81-3123-E00FBB5BC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EE19AD6-687A-3E12-6897-213E7B68C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4FD68E1-DC33-7DFF-4F4E-C7913FFCB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56487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10273BC-BE18-0F31-664B-CFE0DDC385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93800FB-46AE-6ACF-8CBC-8259F1D62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FCE617C-5EA4-9474-31E2-15BDD5E7EF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1C90E8-A8D0-46C7-89FB-C0C2F375278E}" type="datetimeFigureOut">
              <a:rPr lang="es-CL" smtClean="0"/>
              <a:t>17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A0BC1B5-3CF5-48C3-B51C-751AF37B18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E36C81F-FAF5-5C0A-B0AB-3132319A11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C5AB96-76F4-48CC-9D6A-7FE4D9B2CD1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17855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1F1F9529-F0E1-EEAA-367F-7E53DBFDE9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04953"/>
              </p:ext>
            </p:extLst>
          </p:nvPr>
        </p:nvGraphicFramePr>
        <p:xfrm>
          <a:off x="1681097" y="726249"/>
          <a:ext cx="3726540" cy="21124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808989" imgH="2725989" progId="Prism8.Document">
                  <p:embed/>
                </p:oleObj>
              </mc:Choice>
              <mc:Fallback>
                <p:oleObj name="Prism 8" r:id="rId2" imgW="4808989" imgH="2725989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1F1F9529-F0E1-EEAA-367F-7E53DBFDE9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81097" y="726249"/>
                        <a:ext cx="3726540" cy="21124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E3122D64-9CC6-817C-939F-C296FB7F40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127230"/>
              </p:ext>
            </p:extLst>
          </p:nvPr>
        </p:nvGraphicFramePr>
        <p:xfrm>
          <a:off x="6374184" y="613377"/>
          <a:ext cx="3726541" cy="20046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816908" imgH="2701872" progId="Prism8.Document">
                  <p:embed/>
                </p:oleObj>
              </mc:Choice>
              <mc:Fallback>
                <p:oleObj name="Prism 8" r:id="rId4" imgW="4816908" imgH="2701872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E3122D64-9CC6-817C-939F-C296FB7F40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74184" y="613377"/>
                        <a:ext cx="3726541" cy="20046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E22C29BB-21B8-F220-E4F4-431BFCC519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8940498"/>
              </p:ext>
            </p:extLst>
          </p:nvPr>
        </p:nvGraphicFramePr>
        <p:xfrm>
          <a:off x="1763013" y="3252950"/>
          <a:ext cx="3562707" cy="21771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808989" imgH="2938007" progId="Prism8.Document">
                  <p:embed/>
                </p:oleObj>
              </mc:Choice>
              <mc:Fallback>
                <p:oleObj name="Prism 8" r:id="rId6" imgW="4808989" imgH="2938007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E22C29BB-21B8-F220-E4F4-431BFCC519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63013" y="3252950"/>
                        <a:ext cx="3562707" cy="21771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BD215A1C-74EC-5D14-F7D6-B5A973F29A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4616086"/>
              </p:ext>
            </p:extLst>
          </p:nvPr>
        </p:nvGraphicFramePr>
        <p:xfrm>
          <a:off x="6374184" y="3074772"/>
          <a:ext cx="3860642" cy="23553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816908" imgH="2938007" progId="Prism8.Document">
                  <p:embed/>
                </p:oleObj>
              </mc:Choice>
              <mc:Fallback>
                <p:oleObj name="Prism 8" r:id="rId8" imgW="4816908" imgH="2938007" progId="Prism8.Document">
                  <p:embed/>
                  <p:pic>
                    <p:nvPicPr>
                      <p:cNvPr id="8" name="Objeto 7">
                        <a:extLst>
                          <a:ext uri="{FF2B5EF4-FFF2-40B4-BE49-F238E27FC236}">
                            <a16:creationId xmlns:a16="http://schemas.microsoft.com/office/drawing/2014/main" id="{BD215A1C-74EC-5D14-F7D6-B5A973F29A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374184" y="3074772"/>
                        <a:ext cx="3860642" cy="23553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2B0CA148-8C91-4116-D4AB-810E920C0522}"/>
              </a:ext>
            </a:extLst>
          </p:cNvPr>
          <p:cNvSpPr txBox="1"/>
          <p:nvPr/>
        </p:nvSpPr>
        <p:spPr>
          <a:xfrm>
            <a:off x="-646146" y="6065039"/>
            <a:ext cx="11824219" cy="501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: Cell viability to different concentrations of 5-FU and cisplatin in GBC cells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(A, B)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-415 and 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,D)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b-D1 cells viability under different cisplatin and 5-FU concentrations. </a:t>
            </a:r>
            <a:endParaRPr lang="es-CL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C1BC104-30A6-ADCF-1E2D-DD79845ABB62}"/>
              </a:ext>
            </a:extLst>
          </p:cNvPr>
          <p:cNvSpPr txBox="1"/>
          <p:nvPr/>
        </p:nvSpPr>
        <p:spPr>
          <a:xfrm>
            <a:off x="1870819" y="505234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endParaRPr lang="es-CL" sz="1400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BB21585-C982-2958-55E6-5BDA213A58B7}"/>
              </a:ext>
            </a:extLst>
          </p:cNvPr>
          <p:cNvSpPr txBox="1"/>
          <p:nvPr/>
        </p:nvSpPr>
        <p:spPr>
          <a:xfrm>
            <a:off x="1870820" y="3059668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endParaRPr lang="es-CL" sz="1400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EA44011C-79CB-1AA9-397E-ECF9B979AC25}"/>
              </a:ext>
            </a:extLst>
          </p:cNvPr>
          <p:cNvSpPr txBox="1"/>
          <p:nvPr/>
        </p:nvSpPr>
        <p:spPr>
          <a:xfrm>
            <a:off x="6374184" y="428711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endParaRPr lang="es-CL" sz="14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23FCCF5-83B3-7722-34B5-83A5EDEFCE51}"/>
              </a:ext>
            </a:extLst>
          </p:cNvPr>
          <p:cNvSpPr txBox="1"/>
          <p:nvPr/>
        </p:nvSpPr>
        <p:spPr>
          <a:xfrm>
            <a:off x="6374184" y="3068283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endParaRPr lang="es-CL" sz="140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88E58634-0530-10B3-9751-14552E59FBD4}"/>
              </a:ext>
            </a:extLst>
          </p:cNvPr>
          <p:cNvSpPr txBox="1"/>
          <p:nvPr/>
        </p:nvSpPr>
        <p:spPr>
          <a:xfrm>
            <a:off x="2894332" y="91305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-415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273FC399-B8F3-56AA-AB77-DA68076A4C31}"/>
              </a:ext>
            </a:extLst>
          </p:cNvPr>
          <p:cNvSpPr txBox="1"/>
          <p:nvPr/>
        </p:nvSpPr>
        <p:spPr>
          <a:xfrm>
            <a:off x="7674341" y="156610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B-d1</a:t>
            </a:r>
          </a:p>
        </p:txBody>
      </p:sp>
    </p:spTree>
    <p:extLst>
      <p:ext uri="{BB962C8B-B14F-4D97-AF65-F5344CB8AC3E}">
        <p14:creationId xmlns:p14="http://schemas.microsoft.com/office/powerpoint/2010/main" val="14731728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/>
      <p:bldP spid="14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7EFBCE06-B8BD-C371-86A4-6B4904838D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64019"/>
              </p:ext>
            </p:extLst>
          </p:nvPr>
        </p:nvGraphicFramePr>
        <p:xfrm>
          <a:off x="1245085" y="2380731"/>
          <a:ext cx="4679950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679766" imgH="2448819" progId="Prism8.Document">
                  <p:embed/>
                </p:oleObj>
              </mc:Choice>
              <mc:Fallback>
                <p:oleObj name="Prism 8" r:id="rId2" imgW="4679766" imgH="2448819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7EFBCE06-B8BD-C371-86A4-6B4904838D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45085" y="2380731"/>
                        <a:ext cx="4679950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CBEA2E3B-2A52-5BE4-9A5E-5496850B2D9B}"/>
              </a:ext>
            </a:extLst>
          </p:cNvPr>
          <p:cNvSpPr txBox="1"/>
          <p:nvPr/>
        </p:nvSpPr>
        <p:spPr>
          <a:xfrm>
            <a:off x="2844665" y="1518956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-415</a:t>
            </a:r>
          </a:p>
        </p:txBody>
      </p:sp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B84AAC8F-D04C-6135-6073-2C00FF1AEC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1185897"/>
              </p:ext>
            </p:extLst>
          </p:nvPr>
        </p:nvGraphicFramePr>
        <p:xfrm>
          <a:off x="6475898" y="2359932"/>
          <a:ext cx="4702175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02443" imgH="2491654" progId="Prism8.Document">
                  <p:embed/>
                </p:oleObj>
              </mc:Choice>
              <mc:Fallback>
                <p:oleObj name="Prism 8" r:id="rId4" imgW="4702443" imgH="2491654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B84AAC8F-D04C-6135-6073-2C00FF1AEC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75898" y="2359932"/>
                        <a:ext cx="4702175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988DCEFF-997F-2F10-BC12-8E168C17B8A3}"/>
              </a:ext>
            </a:extLst>
          </p:cNvPr>
          <p:cNvSpPr txBox="1"/>
          <p:nvPr/>
        </p:nvSpPr>
        <p:spPr>
          <a:xfrm>
            <a:off x="8265010" y="1518956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B-d1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918EE934-4C38-D2B2-2F5D-0CA714CBA468}"/>
              </a:ext>
            </a:extLst>
          </p:cNvPr>
          <p:cNvSpPr txBox="1"/>
          <p:nvPr/>
        </p:nvSpPr>
        <p:spPr>
          <a:xfrm>
            <a:off x="-534179" y="4852307"/>
            <a:ext cx="11824219" cy="501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Cell proliferation in GBC cells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verexpression of LINC00662 in (A) G-415 and (B) Gb-D1 GBC cells promotes higher proliferation rate at 72 h by trypan blue proliferation assay.</a:t>
            </a:r>
            <a:endParaRPr lang="es-CL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E01A0967-C2ED-78C1-94AE-2AB11A04FF10}"/>
              </a:ext>
            </a:extLst>
          </p:cNvPr>
          <p:cNvSpPr txBox="1"/>
          <p:nvPr/>
        </p:nvSpPr>
        <p:spPr>
          <a:xfrm>
            <a:off x="1513031" y="1888288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endParaRPr lang="es-CL" sz="140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E8DBFB66-1ABB-8F56-94CD-4BA9E7758CC1}"/>
              </a:ext>
            </a:extLst>
          </p:cNvPr>
          <p:cNvSpPr txBox="1"/>
          <p:nvPr/>
        </p:nvSpPr>
        <p:spPr>
          <a:xfrm>
            <a:off x="6853251" y="1888288"/>
            <a:ext cx="3545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endParaRPr lang="es-CL" sz="1400" dirty="0"/>
          </a:p>
        </p:txBody>
      </p:sp>
    </p:spTree>
    <p:extLst>
      <p:ext uri="{BB962C8B-B14F-4D97-AF65-F5344CB8AC3E}">
        <p14:creationId xmlns:p14="http://schemas.microsoft.com/office/powerpoint/2010/main" val="4059076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8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E7FE481F-10F5-F42D-4BF6-92A0A0720A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0920729"/>
              </p:ext>
            </p:extLst>
          </p:nvPr>
        </p:nvGraphicFramePr>
        <p:xfrm>
          <a:off x="8681876" y="2228461"/>
          <a:ext cx="2333625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32864" imgH="3038436" progId="Prism8.Document">
                  <p:embed/>
                </p:oleObj>
              </mc:Choice>
              <mc:Fallback>
                <p:oleObj name="Prism 8" r:id="rId2" imgW="2332864" imgH="3038436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E7FE481F-10F5-F42D-4BF6-92A0A0720A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681876" y="2228461"/>
                        <a:ext cx="2333625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CuadroTexto 8">
            <a:extLst>
              <a:ext uri="{FF2B5EF4-FFF2-40B4-BE49-F238E27FC236}">
                <a16:creationId xmlns:a16="http://schemas.microsoft.com/office/drawing/2014/main" id="{7A9DB80D-C5A2-4EEE-C07E-16469C327CD1}"/>
              </a:ext>
            </a:extLst>
          </p:cNvPr>
          <p:cNvSpPr txBox="1"/>
          <p:nvPr/>
        </p:nvSpPr>
        <p:spPr>
          <a:xfrm>
            <a:off x="10039897" y="1765492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B-d1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6C8DCBC-A1B6-C606-9682-98F440F7C4D4}"/>
              </a:ext>
            </a:extLst>
          </p:cNvPr>
          <p:cNvSpPr txBox="1"/>
          <p:nvPr/>
        </p:nvSpPr>
        <p:spPr>
          <a:xfrm>
            <a:off x="8792057" y="1765492"/>
            <a:ext cx="1480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BBF6C967-3CCD-3A72-2C59-75CF12FC4A78}"/>
              </a:ext>
            </a:extLst>
          </p:cNvPr>
          <p:cNvSpPr txBox="1"/>
          <p:nvPr/>
        </p:nvSpPr>
        <p:spPr>
          <a:xfrm>
            <a:off x="-720791" y="5144762"/>
            <a:ext cx="11824219" cy="501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A representative figure of LINC00662 overexpression in GBC cells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verexpression of LINC00662 in (A) G-415 was detectable and in (B) GB-d1 GBC cells </a:t>
            </a:r>
            <a:r>
              <a:rPr lang="en-US" sz="14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as approximately 50-fold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an </a:t>
            </a:r>
            <a:r>
              <a:rPr lang="en-US" sz="14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mpty vector.</a:t>
            </a:r>
            <a:endParaRPr lang="es-CL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Imagen 13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F4BF055C-0308-11B8-4E90-611EF35B31E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070" y="1765492"/>
            <a:ext cx="6173645" cy="3278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0505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  <p:bldP spid="11" grpId="0"/>
    </p:bld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125</Words>
  <Application>Microsoft Office PowerPoint</Application>
  <PresentationFormat>Panorámica</PresentationFormat>
  <Paragraphs>15</Paragraphs>
  <Slides>3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Palatino Linotype</vt:lpstr>
      <vt:lpstr>Tema de Office</vt:lpstr>
      <vt:lpstr>Prism 8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Perez perez moreno</dc:creator>
  <cp:lastModifiedBy>PPerez perez moreno</cp:lastModifiedBy>
  <cp:revision>1</cp:revision>
  <dcterms:created xsi:type="dcterms:W3CDTF">2024-03-15T22:33:17Z</dcterms:created>
  <dcterms:modified xsi:type="dcterms:W3CDTF">2024-05-18T02:57:18Z</dcterms:modified>
</cp:coreProperties>
</file>